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6699FF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560" autoAdjust="0"/>
    <p:restoredTop sz="94667"/>
  </p:normalViewPr>
  <p:slideViewPr>
    <p:cSldViewPr snapToGrid="0" snapToObjects="1">
      <p:cViewPr varScale="1">
        <p:scale>
          <a:sx n="110" d="100"/>
          <a:sy n="110" d="100"/>
        </p:scale>
        <p:origin x="-612" y="-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synapse.curie.net\Transverse\Pharmacogenomique\collabor\Collaborations%20IVAN\Collaborations\MULTICANCER\(1)%20Manip%20Multicancers_2016_07_19%20DM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chart>
    <c:plotArea>
      <c:layout/>
      <c:barChart>
        <c:barDir val="col"/>
        <c:grouping val="clustered"/>
        <c:ser>
          <c:idx val="0"/>
          <c:order val="0"/>
          <c:tx>
            <c:strRef>
              <c:f>'Pour graph New'!$J$5</c:f>
              <c:strCache>
                <c:ptCount val="1"/>
                <c:pt idx="0">
                  <c:v>Underexpression</c:v>
                </c:pt>
              </c:strCache>
            </c:strRef>
          </c:tx>
          <c:cat>
            <c:strRef>
              <c:f>'Pour graph New'!$C$6:$C$33</c:f>
              <c:strCache>
                <c:ptCount val="28"/>
                <c:pt idx="0">
                  <c:v>Anal canal, n=48</c:v>
                </c:pt>
                <c:pt idx="1">
                  <c:v>HNSCC, n=50</c:v>
                </c:pt>
                <c:pt idx="2">
                  <c:v>Prostate, n=48</c:v>
                </c:pt>
                <c:pt idx="3">
                  <c:v>Ovary, n=52</c:v>
                </c:pt>
                <c:pt idx="4">
                  <c:v>Thyroid, n=31</c:v>
                </c:pt>
                <c:pt idx="5">
                  <c:v>Cervix, n=37</c:v>
                </c:pt>
                <c:pt idx="6">
                  <c:v>Cutaneous melanoma, n=27</c:v>
                </c:pt>
                <c:pt idx="7">
                  <c:v>Endometrium, n=29</c:v>
                </c:pt>
                <c:pt idx="8">
                  <c:v>Total colon carcinoma, n=49</c:v>
                </c:pt>
                <c:pt idx="9">
                  <c:v>◦ Colon metastatic adenocarcinoma, n=25</c:v>
                </c:pt>
                <c:pt idx="10">
                  <c:v>◦ Locally advanced colon adenocarcinoma, n=24</c:v>
                </c:pt>
                <c:pt idx="11">
                  <c:v>Lung adenocarcinoma, n=38</c:v>
                </c:pt>
                <c:pt idx="12">
                  <c:v>Lung squamous cell carcinoma, n=16</c:v>
                </c:pt>
                <c:pt idx="13">
                  <c:v>Kidney, n=22</c:v>
                </c:pt>
                <c:pt idx="14">
                  <c:v>Pancreas, n=22</c:v>
                </c:pt>
                <c:pt idx="15">
                  <c:v>Liver, n=31</c:v>
                </c:pt>
                <c:pt idx="16">
                  <c:v>Total bladder, n=49</c:v>
                </c:pt>
                <c:pt idx="17">
                  <c:v>◦ Superficial urothelial carcinoma, n=25</c:v>
                </c:pt>
                <c:pt idx="18">
                  <c:v>◦ Invasive urothelial carcinoma, n=24</c:v>
                </c:pt>
                <c:pt idx="19">
                  <c:v>Stomach, n=29</c:v>
                </c:pt>
                <c:pt idx="20">
                  <c:v>Total glioma, n=50</c:v>
                </c:pt>
                <c:pt idx="21">
                  <c:v>◦ Low grade glioma (grade II), n=25</c:v>
                </c:pt>
                <c:pt idx="22">
                  <c:v>◦ Glioblastoma (grade IV), n=25</c:v>
                </c:pt>
                <c:pt idx="23">
                  <c:v>Total breast, n=96</c:v>
                </c:pt>
                <c:pt idx="24">
                  <c:v>◦ Triple negative breast carcinoma, n=24</c:v>
                </c:pt>
                <c:pt idx="25">
                  <c:v>◦ HR-ERBB2+ breast carcinoma, n=24</c:v>
                </c:pt>
                <c:pt idx="26">
                  <c:v>◦ HR+ ERBB2- breast carcinoma, n=24</c:v>
                </c:pt>
                <c:pt idx="27">
                  <c:v>◦ HR+ ERBB2+ breast carcinoma, n=24</c:v>
                </c:pt>
              </c:strCache>
            </c:strRef>
          </c:cat>
          <c:val>
            <c:numRef>
              <c:f>'Pour graph New'!$J$6:$J$33</c:f>
              <c:numCache>
                <c:formatCode>0.0%</c:formatCode>
                <c:ptCount val="28"/>
                <c:pt idx="0">
                  <c:v>0.14583333333333345</c:v>
                </c:pt>
                <c:pt idx="1">
                  <c:v>0.38000000000000017</c:v>
                </c:pt>
                <c:pt idx="2">
                  <c:v>8.3333333333333343E-2</c:v>
                </c:pt>
                <c:pt idx="3">
                  <c:v>0.11538461538461539</c:v>
                </c:pt>
                <c:pt idx="4">
                  <c:v>0</c:v>
                </c:pt>
                <c:pt idx="5">
                  <c:v>5.4054054054054085E-2</c:v>
                </c:pt>
                <c:pt idx="6">
                  <c:v>0.59259259259259267</c:v>
                </c:pt>
                <c:pt idx="7">
                  <c:v>3.4482758620689655E-2</c:v>
                </c:pt>
                <c:pt idx="8">
                  <c:v>0.89795918367346961</c:v>
                </c:pt>
                <c:pt idx="9">
                  <c:v>0.9600000000000003</c:v>
                </c:pt>
                <c:pt idx="10">
                  <c:v>0.8333333333333337</c:v>
                </c:pt>
                <c:pt idx="11">
                  <c:v>2.6315789473684216E-2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.16</c:v>
                </c:pt>
                <c:pt idx="17">
                  <c:v>0.28000000000000008</c:v>
                </c:pt>
                <c:pt idx="18">
                  <c:v>4.1666666666666664E-2</c:v>
                </c:pt>
                <c:pt idx="19">
                  <c:v>0</c:v>
                </c:pt>
                <c:pt idx="20">
                  <c:v>0.12000000000000002</c:v>
                </c:pt>
                <c:pt idx="21">
                  <c:v>4.0000000000000022E-2</c:v>
                </c:pt>
                <c:pt idx="22">
                  <c:v>0.2</c:v>
                </c:pt>
                <c:pt idx="23">
                  <c:v>5.2083333333333398E-2</c:v>
                </c:pt>
                <c:pt idx="24">
                  <c:v>0.125</c:v>
                </c:pt>
                <c:pt idx="25">
                  <c:v>0</c:v>
                </c:pt>
                <c:pt idx="26">
                  <c:v>4.1666666666666664E-2</c:v>
                </c:pt>
                <c:pt idx="27">
                  <c:v>4.1666666666666664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4F2-4C18-AAF9-A91DC35D5C39}"/>
            </c:ext>
          </c:extLst>
        </c:ser>
        <c:ser>
          <c:idx val="1"/>
          <c:order val="1"/>
          <c:tx>
            <c:strRef>
              <c:f>'Pour graph New'!$K$5</c:f>
              <c:strCache>
                <c:ptCount val="1"/>
                <c:pt idx="0">
                  <c:v>% expr normale</c:v>
                </c:pt>
              </c:strCache>
            </c:strRef>
          </c:tx>
          <c:spPr>
            <a:solidFill>
              <a:srgbClr val="00B050"/>
            </a:solidFill>
          </c:spPr>
          <c:cat>
            <c:strRef>
              <c:f>'Pour graph New'!$C$6:$C$33</c:f>
              <c:strCache>
                <c:ptCount val="28"/>
                <c:pt idx="0">
                  <c:v>Anal canal, n=48</c:v>
                </c:pt>
                <c:pt idx="1">
                  <c:v>HNSCC, n=50</c:v>
                </c:pt>
                <c:pt idx="2">
                  <c:v>Prostate, n=48</c:v>
                </c:pt>
                <c:pt idx="3">
                  <c:v>Ovary, n=52</c:v>
                </c:pt>
                <c:pt idx="4">
                  <c:v>Thyroid, n=31</c:v>
                </c:pt>
                <c:pt idx="5">
                  <c:v>Cervix, n=37</c:v>
                </c:pt>
                <c:pt idx="6">
                  <c:v>Cutaneous melanoma, n=27</c:v>
                </c:pt>
                <c:pt idx="7">
                  <c:v>Endometrium, n=29</c:v>
                </c:pt>
                <c:pt idx="8">
                  <c:v>Total colon carcinoma, n=49</c:v>
                </c:pt>
                <c:pt idx="9">
                  <c:v>◦ Colon metastatic adenocarcinoma, n=25</c:v>
                </c:pt>
                <c:pt idx="10">
                  <c:v>◦ Locally advanced colon adenocarcinoma, n=24</c:v>
                </c:pt>
                <c:pt idx="11">
                  <c:v>Lung adenocarcinoma, n=38</c:v>
                </c:pt>
                <c:pt idx="12">
                  <c:v>Lung squamous cell carcinoma, n=16</c:v>
                </c:pt>
                <c:pt idx="13">
                  <c:v>Kidney, n=22</c:v>
                </c:pt>
                <c:pt idx="14">
                  <c:v>Pancreas, n=22</c:v>
                </c:pt>
                <c:pt idx="15">
                  <c:v>Liver, n=31</c:v>
                </c:pt>
                <c:pt idx="16">
                  <c:v>Total bladder, n=49</c:v>
                </c:pt>
                <c:pt idx="17">
                  <c:v>◦ Superficial urothelial carcinoma, n=25</c:v>
                </c:pt>
                <c:pt idx="18">
                  <c:v>◦ Invasive urothelial carcinoma, n=24</c:v>
                </c:pt>
                <c:pt idx="19">
                  <c:v>Stomach, n=29</c:v>
                </c:pt>
                <c:pt idx="20">
                  <c:v>Total glioma, n=50</c:v>
                </c:pt>
                <c:pt idx="21">
                  <c:v>◦ Low grade glioma (grade II), n=25</c:v>
                </c:pt>
                <c:pt idx="22">
                  <c:v>◦ Glioblastoma (grade IV), n=25</c:v>
                </c:pt>
                <c:pt idx="23">
                  <c:v>Total breast, n=96</c:v>
                </c:pt>
                <c:pt idx="24">
                  <c:v>◦ Triple negative breast carcinoma, n=24</c:v>
                </c:pt>
                <c:pt idx="25">
                  <c:v>◦ HR-ERBB2+ breast carcinoma, n=24</c:v>
                </c:pt>
                <c:pt idx="26">
                  <c:v>◦ HR+ ERBB2- breast carcinoma, n=24</c:v>
                </c:pt>
                <c:pt idx="27">
                  <c:v>◦ HR+ ERBB2+ breast carcinoma, n=24</c:v>
                </c:pt>
              </c:strCache>
            </c:strRef>
          </c:cat>
          <c:val>
            <c:numRef>
              <c:f>'Pour graph New'!$K$6:$K$33</c:f>
              <c:numCache>
                <c:formatCode>0.0%</c:formatCode>
                <c:ptCount val="28"/>
                <c:pt idx="0">
                  <c:v>0.85416666666666652</c:v>
                </c:pt>
                <c:pt idx="1">
                  <c:v>0.52</c:v>
                </c:pt>
                <c:pt idx="2">
                  <c:v>0.91666666666666652</c:v>
                </c:pt>
                <c:pt idx="3">
                  <c:v>0.51923076923076883</c:v>
                </c:pt>
                <c:pt idx="4">
                  <c:v>0.22580645161290333</c:v>
                </c:pt>
                <c:pt idx="5">
                  <c:v>0.59459459459459463</c:v>
                </c:pt>
                <c:pt idx="6">
                  <c:v>0.40740740740740761</c:v>
                </c:pt>
                <c:pt idx="7">
                  <c:v>0.65517241379310398</c:v>
                </c:pt>
                <c:pt idx="8">
                  <c:v>0.10204081632653061</c:v>
                </c:pt>
                <c:pt idx="9">
                  <c:v>4.0000000000000056E-2</c:v>
                </c:pt>
                <c:pt idx="10">
                  <c:v>0.16666666666666663</c:v>
                </c:pt>
                <c:pt idx="11">
                  <c:v>0.6842105263157896</c:v>
                </c:pt>
                <c:pt idx="12">
                  <c:v>0.5625</c:v>
                </c:pt>
                <c:pt idx="13">
                  <c:v>0.22727272727272727</c:v>
                </c:pt>
                <c:pt idx="14">
                  <c:v>9.0909090909091037E-2</c:v>
                </c:pt>
                <c:pt idx="15">
                  <c:v>0.45161290322580683</c:v>
                </c:pt>
                <c:pt idx="16">
                  <c:v>0.52</c:v>
                </c:pt>
                <c:pt idx="17">
                  <c:v>0.55999999999999994</c:v>
                </c:pt>
                <c:pt idx="18">
                  <c:v>0.45833333333333326</c:v>
                </c:pt>
                <c:pt idx="19">
                  <c:v>0.68965517241379393</c:v>
                </c:pt>
                <c:pt idx="20">
                  <c:v>0.54</c:v>
                </c:pt>
                <c:pt idx="21">
                  <c:v>0.48000000000000015</c:v>
                </c:pt>
                <c:pt idx="22">
                  <c:v>0.60000000000000031</c:v>
                </c:pt>
                <c:pt idx="23">
                  <c:v>0.80208333333333359</c:v>
                </c:pt>
                <c:pt idx="24">
                  <c:v>0.58333333333333326</c:v>
                </c:pt>
                <c:pt idx="25">
                  <c:v>0.8333333333333337</c:v>
                </c:pt>
                <c:pt idx="26">
                  <c:v>0.9583333333333337</c:v>
                </c:pt>
                <c:pt idx="27">
                  <c:v>0.833333333333333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4F2-4C18-AAF9-A91DC35D5C39}"/>
            </c:ext>
          </c:extLst>
        </c:ser>
        <c:ser>
          <c:idx val="2"/>
          <c:order val="2"/>
          <c:tx>
            <c:strRef>
              <c:f>'Pour graph New'!$L$5</c:f>
              <c:strCache>
                <c:ptCount val="1"/>
                <c:pt idx="0">
                  <c:v>Overexpression</c:v>
                </c:pt>
              </c:strCache>
            </c:strRef>
          </c:tx>
          <c:spPr>
            <a:solidFill>
              <a:srgbClr val="FF0000"/>
            </a:solidFill>
          </c:spPr>
          <c:cat>
            <c:strRef>
              <c:f>'Pour graph New'!$C$6:$C$33</c:f>
              <c:strCache>
                <c:ptCount val="28"/>
                <c:pt idx="0">
                  <c:v>Anal canal, n=48</c:v>
                </c:pt>
                <c:pt idx="1">
                  <c:v>HNSCC, n=50</c:v>
                </c:pt>
                <c:pt idx="2">
                  <c:v>Prostate, n=48</c:v>
                </c:pt>
                <c:pt idx="3">
                  <c:v>Ovary, n=52</c:v>
                </c:pt>
                <c:pt idx="4">
                  <c:v>Thyroid, n=31</c:v>
                </c:pt>
                <c:pt idx="5">
                  <c:v>Cervix, n=37</c:v>
                </c:pt>
                <c:pt idx="6">
                  <c:v>Cutaneous melanoma, n=27</c:v>
                </c:pt>
                <c:pt idx="7">
                  <c:v>Endometrium, n=29</c:v>
                </c:pt>
                <c:pt idx="8">
                  <c:v>Total colon carcinoma, n=49</c:v>
                </c:pt>
                <c:pt idx="9">
                  <c:v>◦ Colon metastatic adenocarcinoma, n=25</c:v>
                </c:pt>
                <c:pt idx="10">
                  <c:v>◦ Locally advanced colon adenocarcinoma, n=24</c:v>
                </c:pt>
                <c:pt idx="11">
                  <c:v>Lung adenocarcinoma, n=38</c:v>
                </c:pt>
                <c:pt idx="12">
                  <c:v>Lung squamous cell carcinoma, n=16</c:v>
                </c:pt>
                <c:pt idx="13">
                  <c:v>Kidney, n=22</c:v>
                </c:pt>
                <c:pt idx="14">
                  <c:v>Pancreas, n=22</c:v>
                </c:pt>
                <c:pt idx="15">
                  <c:v>Liver, n=31</c:v>
                </c:pt>
                <c:pt idx="16">
                  <c:v>Total bladder, n=49</c:v>
                </c:pt>
                <c:pt idx="17">
                  <c:v>◦ Superficial urothelial carcinoma, n=25</c:v>
                </c:pt>
                <c:pt idx="18">
                  <c:v>◦ Invasive urothelial carcinoma, n=24</c:v>
                </c:pt>
                <c:pt idx="19">
                  <c:v>Stomach, n=29</c:v>
                </c:pt>
                <c:pt idx="20">
                  <c:v>Total glioma, n=50</c:v>
                </c:pt>
                <c:pt idx="21">
                  <c:v>◦ Low grade glioma (grade II), n=25</c:v>
                </c:pt>
                <c:pt idx="22">
                  <c:v>◦ Glioblastoma (grade IV), n=25</c:v>
                </c:pt>
                <c:pt idx="23">
                  <c:v>Total breast, n=96</c:v>
                </c:pt>
                <c:pt idx="24">
                  <c:v>◦ Triple negative breast carcinoma, n=24</c:v>
                </c:pt>
                <c:pt idx="25">
                  <c:v>◦ HR-ERBB2+ breast carcinoma, n=24</c:v>
                </c:pt>
                <c:pt idx="26">
                  <c:v>◦ HR+ ERBB2- breast carcinoma, n=24</c:v>
                </c:pt>
                <c:pt idx="27">
                  <c:v>◦ HR+ ERBB2+ breast carcinoma, n=24</c:v>
                </c:pt>
              </c:strCache>
            </c:strRef>
          </c:cat>
          <c:val>
            <c:numRef>
              <c:f>'Pour graph New'!$L$6:$L$33</c:f>
              <c:numCache>
                <c:formatCode>0.0%</c:formatCode>
                <c:ptCount val="28"/>
                <c:pt idx="0">
                  <c:v>0</c:v>
                </c:pt>
                <c:pt idx="1">
                  <c:v>0.1</c:v>
                </c:pt>
                <c:pt idx="2">
                  <c:v>0</c:v>
                </c:pt>
                <c:pt idx="3">
                  <c:v>0.36538461538461597</c:v>
                </c:pt>
                <c:pt idx="4">
                  <c:v>0.77419354838709675</c:v>
                </c:pt>
                <c:pt idx="5">
                  <c:v>0.35135135135135137</c:v>
                </c:pt>
                <c:pt idx="6">
                  <c:v>0</c:v>
                </c:pt>
                <c:pt idx="7">
                  <c:v>0.31034482758620707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.28947368421052638</c:v>
                </c:pt>
                <c:pt idx="12">
                  <c:v>0.43750000000000017</c:v>
                </c:pt>
                <c:pt idx="13">
                  <c:v>0.77272727272727304</c:v>
                </c:pt>
                <c:pt idx="14">
                  <c:v>0.90909090909090906</c:v>
                </c:pt>
                <c:pt idx="15">
                  <c:v>0.54838709677419362</c:v>
                </c:pt>
                <c:pt idx="16">
                  <c:v>0.32000000000000017</c:v>
                </c:pt>
                <c:pt idx="17">
                  <c:v>0.16</c:v>
                </c:pt>
                <c:pt idx="18">
                  <c:v>0.5</c:v>
                </c:pt>
                <c:pt idx="19">
                  <c:v>0.31034482758620707</c:v>
                </c:pt>
                <c:pt idx="20">
                  <c:v>0.34</c:v>
                </c:pt>
                <c:pt idx="21">
                  <c:v>0.48000000000000015</c:v>
                </c:pt>
                <c:pt idx="22">
                  <c:v>0.2</c:v>
                </c:pt>
                <c:pt idx="23">
                  <c:v>0.14583333333333345</c:v>
                </c:pt>
                <c:pt idx="24">
                  <c:v>0.29166666666666691</c:v>
                </c:pt>
                <c:pt idx="25">
                  <c:v>0.16666666666666666</c:v>
                </c:pt>
                <c:pt idx="26">
                  <c:v>0</c:v>
                </c:pt>
                <c:pt idx="27">
                  <c:v>0.1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4F2-4C18-AAF9-A91DC35D5C39}"/>
            </c:ext>
          </c:extLst>
        </c:ser>
        <c:axId val="69274624"/>
        <c:axId val="69276416"/>
      </c:barChart>
      <c:catAx>
        <c:axId val="69274624"/>
        <c:scaling>
          <c:orientation val="minMax"/>
        </c:scaling>
        <c:axPos val="b"/>
        <c:numFmt formatCode="General" sourceLinked="1"/>
        <c:tickLblPos val="nextTo"/>
        <c:crossAx val="69276416"/>
        <c:crosses val="autoZero"/>
        <c:auto val="1"/>
        <c:lblAlgn val="ctr"/>
        <c:lblOffset val="100"/>
      </c:catAx>
      <c:valAx>
        <c:axId val="69276416"/>
        <c:scaling>
          <c:orientation val="minMax"/>
          <c:max val="1"/>
        </c:scaling>
        <c:axPos val="l"/>
        <c:majorGridlines/>
        <c:numFmt formatCode="0%" sourceLinked="0"/>
        <c:tickLblPos val="nextTo"/>
        <c:crossAx val="69274624"/>
        <c:crosses val="autoZero"/>
        <c:crossBetween val="between"/>
      </c:valAx>
    </c:plotArea>
    <c:plotVisOnly val="1"/>
    <c:dispBlanksAs val="gap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Cliquez pour modifier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006728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7667911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09710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938321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5718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175833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0842743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0009279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891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7260896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16055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226332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349631" y="171326"/>
            <a:ext cx="930223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dirty="0" err="1">
                <a:latin typeface="Times New Roman" charset="0"/>
                <a:ea typeface="Times New Roman" charset="0"/>
                <a:cs typeface="Times New Roman" charset="0"/>
              </a:rPr>
              <a:t>Supplemental</a:t>
            </a:r>
            <a:r>
              <a:rPr lang="fr-FR" dirty="0">
                <a:latin typeface="Times New Roman" charset="0"/>
                <a:ea typeface="Times New Roman" charset="0"/>
                <a:cs typeface="Times New Roman" charset="0"/>
              </a:rPr>
              <a:t> Figure </a:t>
            </a:r>
            <a:r>
              <a:rPr lang="fr-FR" dirty="0" smtClean="0">
                <a:latin typeface="Times New Roman" charset="0"/>
                <a:ea typeface="Times New Roman" charset="0"/>
                <a:cs typeface="Times New Roman" charset="0"/>
              </a:rPr>
              <a:t>2C: </a:t>
            </a:r>
            <a:r>
              <a:rPr lang="fr-FR" dirty="0" err="1">
                <a:latin typeface="Times New Roman" charset="0"/>
                <a:ea typeface="Times New Roman" charset="0"/>
                <a:cs typeface="Times New Roman" charset="0"/>
              </a:rPr>
              <a:t>Percentage</a:t>
            </a:r>
            <a:r>
              <a:rPr lang="fr-FR" dirty="0">
                <a:latin typeface="Times New Roman" charset="0"/>
                <a:ea typeface="Times New Roman" charset="0"/>
                <a:cs typeface="Times New Roman" charset="0"/>
              </a:rPr>
              <a:t> of </a:t>
            </a:r>
            <a:r>
              <a:rPr lang="fr-FR" dirty="0" err="1">
                <a:latin typeface="Times New Roman" charset="0"/>
                <a:ea typeface="Times New Roman" charset="0"/>
                <a:cs typeface="Times New Roman" charset="0"/>
              </a:rPr>
              <a:t>underexpression</a:t>
            </a:r>
            <a:r>
              <a:rPr lang="fr-FR" dirty="0">
                <a:latin typeface="Times New Roman" charset="0"/>
                <a:ea typeface="Times New Roman" charset="0"/>
                <a:cs typeface="Times New Roman" charset="0"/>
              </a:rPr>
              <a:t>, normal expression and </a:t>
            </a:r>
            <a:r>
              <a:rPr lang="fr-FR" dirty="0" err="1">
                <a:latin typeface="Times New Roman" charset="0"/>
                <a:ea typeface="Times New Roman" charset="0"/>
                <a:cs typeface="Times New Roman" charset="0"/>
              </a:rPr>
              <a:t>overexpression</a:t>
            </a:r>
            <a:r>
              <a:rPr lang="fr-FR" dirty="0">
                <a:latin typeface="Times New Roman" charset="0"/>
                <a:ea typeface="Times New Roman" charset="0"/>
                <a:cs typeface="Times New Roman" charset="0"/>
              </a:rPr>
              <a:t> of </a:t>
            </a:r>
            <a:r>
              <a:rPr lang="fr-FR" i="1" dirty="0">
                <a:latin typeface="Times New Roman" charset="0"/>
                <a:ea typeface="Times New Roman" charset="0"/>
                <a:cs typeface="Times New Roman" charset="0"/>
              </a:rPr>
              <a:t>CDKN2B/p15 </a:t>
            </a:r>
            <a:r>
              <a:rPr lang="fr-FR" dirty="0">
                <a:latin typeface="Times New Roman" charset="0"/>
                <a:ea typeface="Times New Roman" charset="0"/>
                <a:cs typeface="Times New Roman" charset="0"/>
              </a:rPr>
              <a:t>in </a:t>
            </a:r>
            <a:r>
              <a:rPr lang="fr-FR" dirty="0" err="1">
                <a:latin typeface="Times New Roman" charset="0"/>
                <a:ea typeface="Times New Roman" charset="0"/>
                <a:cs typeface="Times New Roman" charset="0"/>
              </a:rPr>
              <a:t>tumor</a:t>
            </a:r>
            <a:r>
              <a:rPr lang="fr-FR" dirty="0">
                <a:latin typeface="Times New Roman" charset="0"/>
                <a:ea typeface="Times New Roman" charset="0"/>
                <a:cs typeface="Times New Roman" charset="0"/>
              </a:rPr>
              <a:t> tissues</a:t>
            </a:r>
            <a:endParaRPr lang="en-GB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grpSp>
        <p:nvGrpSpPr>
          <p:cNvPr id="8" name="Groupe 7"/>
          <p:cNvGrpSpPr/>
          <p:nvPr/>
        </p:nvGrpSpPr>
        <p:grpSpPr>
          <a:xfrm>
            <a:off x="236066" y="5680397"/>
            <a:ext cx="1333130" cy="307777"/>
            <a:chOff x="236066" y="5680397"/>
            <a:chExt cx="1333130" cy="307777"/>
          </a:xfrm>
        </p:grpSpPr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xmlns="" id="{8788BA19-B4DF-2244-A687-6B898DC6C382}"/>
                </a:ext>
              </a:extLst>
            </p:cNvPr>
            <p:cNvSpPr/>
            <p:nvPr/>
          </p:nvSpPr>
          <p:spPr>
            <a:xfrm>
              <a:off x="236066" y="5749354"/>
              <a:ext cx="196850" cy="169863"/>
            </a:xfrm>
            <a:prstGeom prst="rect">
              <a:avLst/>
            </a:prstGeom>
            <a:solidFill>
              <a:srgbClr val="6699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fr-FR" altLang="fr-FR" sz="1800">
                <a:solidFill>
                  <a:srgbClr val="FFFFFF"/>
                </a:solidFill>
                <a:ea typeface="Arial" charset="0"/>
                <a:cs typeface="Arial" charset="0"/>
              </a:endParaRPr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xmlns="" id="{B2A33663-54E5-0042-944D-FDAD7E594BB4}"/>
                </a:ext>
              </a:extLst>
            </p:cNvPr>
            <p:cNvSpPr txBox="1"/>
            <p:nvPr/>
          </p:nvSpPr>
          <p:spPr>
            <a:xfrm>
              <a:off x="385859" y="5680397"/>
              <a:ext cx="11833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 err="1">
                  <a:latin typeface="Times New Roman" charset="0"/>
                  <a:ea typeface="Times New Roman" charset="0"/>
                  <a:cs typeface="Times New Roman" charset="0"/>
                </a:rPr>
                <a:t>Underexpression</a:t>
              </a:r>
              <a:r>
                <a:rPr lang="en-GB" sz="1400" dirty="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</a:p>
          </p:txBody>
        </p:sp>
      </p:grpSp>
      <p:grpSp>
        <p:nvGrpSpPr>
          <p:cNvPr id="13" name="Groupe 12"/>
          <p:cNvGrpSpPr/>
          <p:nvPr/>
        </p:nvGrpSpPr>
        <p:grpSpPr>
          <a:xfrm>
            <a:off x="236066" y="6330533"/>
            <a:ext cx="1262598" cy="307777"/>
            <a:chOff x="236066" y="6330533"/>
            <a:chExt cx="1262598" cy="307777"/>
          </a:xfrm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xmlns="" id="{4EE6C6BF-2E7E-C040-A0BC-02D2F0C3236B}"/>
                </a:ext>
              </a:extLst>
            </p:cNvPr>
            <p:cNvSpPr/>
            <p:nvPr/>
          </p:nvSpPr>
          <p:spPr>
            <a:xfrm>
              <a:off x="236066" y="6399490"/>
              <a:ext cx="196850" cy="169863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fr-FR" altLang="fr-FR" sz="1800">
                <a:solidFill>
                  <a:srgbClr val="FFFFFF"/>
                </a:solidFill>
                <a:ea typeface="Arial" charset="0"/>
                <a:cs typeface="Arial" charset="0"/>
              </a:endParaRPr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xmlns="" id="{BE0DA22C-95E9-0744-BE49-543481685BF3}"/>
                </a:ext>
              </a:extLst>
            </p:cNvPr>
            <p:cNvSpPr txBox="1"/>
            <p:nvPr/>
          </p:nvSpPr>
          <p:spPr>
            <a:xfrm>
              <a:off x="385859" y="6330533"/>
              <a:ext cx="11128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>
                  <a:latin typeface="Times New Roman" charset="0"/>
                  <a:ea typeface="Times New Roman" charset="0"/>
                  <a:cs typeface="Times New Roman" charset="0"/>
                </a:rPr>
                <a:t>Overexpression</a:t>
              </a:r>
              <a:r>
                <a:rPr lang="en-GB" sz="1400" dirty="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</a:p>
          </p:txBody>
        </p:sp>
      </p:grpSp>
      <p:grpSp>
        <p:nvGrpSpPr>
          <p:cNvPr id="17" name="Groupe 16"/>
          <p:cNvGrpSpPr/>
          <p:nvPr/>
        </p:nvGrpSpPr>
        <p:grpSpPr>
          <a:xfrm>
            <a:off x="236066" y="6005465"/>
            <a:ext cx="1445340" cy="307777"/>
            <a:chOff x="236066" y="5990684"/>
            <a:chExt cx="1445340" cy="307777"/>
          </a:xfrm>
        </p:grpSpPr>
        <p:sp>
          <p:nvSpPr>
            <p:cNvPr id="18" name="Rectangle 17"/>
            <p:cNvSpPr/>
            <p:nvPr/>
          </p:nvSpPr>
          <p:spPr>
            <a:xfrm>
              <a:off x="236066" y="6059641"/>
              <a:ext cx="196850" cy="169863"/>
            </a:xfrm>
            <a:prstGeom prst="rect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fr-FR" altLang="fr-FR" sz="1800">
                <a:solidFill>
                  <a:srgbClr val="FFFFFF"/>
                </a:solidFill>
                <a:ea typeface="Arial" charset="0"/>
                <a:cs typeface="Arial" charset="0"/>
              </a:endParaRPr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385859" y="5990684"/>
              <a:ext cx="12955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>
                  <a:latin typeface="Times New Roman" charset="0"/>
                  <a:ea typeface="Times New Roman" charset="0"/>
                  <a:cs typeface="Times New Roman" charset="0"/>
                </a:rPr>
                <a:t>Normal expression</a:t>
              </a:r>
              <a:r>
                <a:rPr lang="en-GB" sz="1400" dirty="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</a:p>
          </p:txBody>
        </p:sp>
      </p:grpSp>
      <p:graphicFrame>
        <p:nvGraphicFramePr>
          <p:cNvPr id="22" name="Graphiqu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677921658"/>
              </p:ext>
            </p:extLst>
          </p:nvPr>
        </p:nvGraphicFramePr>
        <p:xfrm>
          <a:off x="1444881" y="780435"/>
          <a:ext cx="9302238" cy="60837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xmlns="" val="193440212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1</TotalTime>
  <Words>21</Words>
  <Application>Microsoft Office PowerPoint</Application>
  <PresentationFormat>Personnalisé</PresentationFormat>
  <Paragraphs>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Kinan Drak Alsibai</dc:creator>
  <cp:lastModifiedBy>mohamed.drakalsibai</cp:lastModifiedBy>
  <cp:revision>39</cp:revision>
  <dcterms:created xsi:type="dcterms:W3CDTF">2018-01-21T05:51:31Z</dcterms:created>
  <dcterms:modified xsi:type="dcterms:W3CDTF">2019-08-07T20:46:57Z</dcterms:modified>
</cp:coreProperties>
</file>